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9" autoAdjust="0"/>
    <p:restoredTop sz="94660"/>
  </p:normalViewPr>
  <p:slideViewPr>
    <p:cSldViewPr snapToGrid="0">
      <p:cViewPr varScale="1">
        <p:scale>
          <a:sx n="97" d="100"/>
          <a:sy n="97" d="100"/>
        </p:scale>
        <p:origin x="1056" y="30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1F3F582-8660-4E2F-B97E-683EEC240E3D}" type="doc">
      <dgm:prSet loTypeId="urn:microsoft.com/office/officeart/2005/8/layout/vList5" loCatId="list" qsTypeId="urn:microsoft.com/office/officeart/2005/8/quickstyle/simple3" qsCatId="simple" csTypeId="urn:microsoft.com/office/officeart/2005/8/colors/accent1_3" csCatId="accent1" phldr="1"/>
      <dgm:spPr/>
    </dgm:pt>
    <dgm:pt modelId="{D3960BAD-EC9F-4A2A-98F7-5FD1044001AD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,923 proteins</a:t>
          </a:r>
          <a:endParaRPr lang="de-DE" b="1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B51419B-3375-4C32-BAC8-69A1E85FF5B3}" type="parTrans" cxnId="{F1573093-349E-4B6E-9004-530A2AB94AFB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0CD14DCE-6BBE-4E98-B1FC-DB7D09CF0691}" type="sibTrans" cxnId="{F1573093-349E-4B6E-9004-530A2AB94AFB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76DBA1F2-425C-43CF-913C-E4BDDB1AE249}">
      <dgm:prSet phldrT="[Text]"/>
      <dgm:spPr/>
      <dgm:t>
        <a:bodyPr anchor="t"/>
        <a:lstStyle/>
        <a:p>
          <a:r>
            <a:rPr lang="en-US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825 </a:t>
          </a:r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proteins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 with more than 25% of values below the limit of detection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50102F50-0051-4165-8199-A69C0A61F220}" type="parTrans" cxnId="{13CB2C69-89B8-4BBA-91A3-58DAB0B5CDA7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AD1EFCB2-3F22-42BA-A58A-FB4EA30F9247}" type="sibTrans" cxnId="{13CB2C69-89B8-4BBA-91A3-58DAB0B5CDA7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47BCCA7-A393-48E7-B26C-02E9E6E42220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8 proteins 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more than 20% missing data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E1E6ADE2-45D3-42E0-BEE8-5F460D8E1F47}" type="parTrans" cxnId="{8F5B0B1F-AD28-49A1-BC18-CDA43607EEFA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40E0607F-2AC8-4B55-8AF4-64DBB11E27AE}" type="sibTrans" cxnId="{8F5B0B1F-AD28-49A1-BC18-CDA43607EEFA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6C903908-5B54-47E0-AD16-3AB79B184B38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0 proteins 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highly skewed* distribution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CB48CC08-05E1-475A-87D9-C000AD6DDD6F}" type="parTrans" cxnId="{EF23C948-17AB-4F06-9A0A-12EBC3C02C00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C488F05-C2DD-41A8-94EC-B03FB4A10803}" type="sibTrans" cxnId="{EF23C948-17AB-4F06-9A0A-12EBC3C02C00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26B6E8F3-4A91-4E8A-873F-BC8C1BB8C749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,040 proteins</a:t>
          </a:r>
          <a:endParaRPr lang="de-DE" b="1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04BE29CB-1DBB-4ACC-906C-773A29269557}" type="parTrans" cxnId="{49A674B5-83E1-4248-A542-25608675CEE3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872B72EA-FA56-4763-97CD-4F1B6E37F102}" type="sibTrans" cxnId="{49A674B5-83E1-4248-A542-25608675CEE3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FDAB2C87-7C26-40D6-896E-3F76556EBE39}">
      <dgm:prSet phldrT="[Text]"/>
      <dgm:spPr/>
      <dgm:t>
        <a:bodyPr anchor="t"/>
        <a:lstStyle/>
        <a:p>
          <a:r>
            <a:rPr lang="de-D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UK Biobank </a:t>
          </a:r>
        </a:p>
        <a:p>
          <a:r>
            <a:rPr lang="de-D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Olink Explore 3072</a:t>
          </a:r>
        </a:p>
      </dgm:t>
    </dgm:pt>
    <dgm:pt modelId="{3273BE2E-782C-47F9-ADB9-30D85A17ED5E}" type="parTrans" cxnId="{80DB3209-7EED-48D9-BA10-997BC00AF3A1}">
      <dgm:prSet/>
      <dgm:spPr/>
      <dgm:t>
        <a:bodyPr/>
        <a:lstStyle/>
        <a:p>
          <a:endParaRPr lang="de-DE"/>
        </a:p>
      </dgm:t>
    </dgm:pt>
    <dgm:pt modelId="{87E73D53-D5D7-48F4-96ED-37E9FFF949E8}" type="sibTrans" cxnId="{80DB3209-7EED-48D9-BA10-997BC00AF3A1}">
      <dgm:prSet/>
      <dgm:spPr/>
      <dgm:t>
        <a:bodyPr/>
        <a:lstStyle/>
        <a:p>
          <a:endParaRPr lang="de-DE"/>
        </a:p>
      </dgm:t>
    </dgm:pt>
    <dgm:pt modelId="{C4627956-46C1-4C9C-862F-D632754C713D}" type="pres">
      <dgm:prSet presAssocID="{91F3F582-8660-4E2F-B97E-683EEC240E3D}" presName="Name0" presStyleCnt="0">
        <dgm:presLayoutVars>
          <dgm:dir/>
          <dgm:animLvl val="lvl"/>
          <dgm:resizeHandles val="exact"/>
        </dgm:presLayoutVars>
      </dgm:prSet>
      <dgm:spPr/>
    </dgm:pt>
    <dgm:pt modelId="{C6BD7D8A-4FAC-47FD-BCAC-A732E04FF69B}" type="pres">
      <dgm:prSet presAssocID="{FDAB2C87-7C26-40D6-896E-3F76556EBE39}" presName="linNode" presStyleCnt="0"/>
      <dgm:spPr/>
    </dgm:pt>
    <dgm:pt modelId="{20BEAB21-ADCA-4148-931A-9126F5F5038D}" type="pres">
      <dgm:prSet presAssocID="{FDAB2C87-7C26-40D6-896E-3F76556EBE39}" presName="parentText" presStyleLbl="node1" presStyleIdx="0" presStyleCnt="6">
        <dgm:presLayoutVars>
          <dgm:chMax val="1"/>
          <dgm:bulletEnabled val="1"/>
        </dgm:presLayoutVars>
      </dgm:prSet>
      <dgm:spPr/>
    </dgm:pt>
    <dgm:pt modelId="{AD76DBB9-BF65-46EC-B7F8-5215118C7379}" type="pres">
      <dgm:prSet presAssocID="{87E73D53-D5D7-48F4-96ED-37E9FFF949E8}" presName="sp" presStyleCnt="0"/>
      <dgm:spPr/>
    </dgm:pt>
    <dgm:pt modelId="{698F7748-C46E-4397-801C-7C43FD66735B}" type="pres">
      <dgm:prSet presAssocID="{D3960BAD-EC9F-4A2A-98F7-5FD1044001AD}" presName="linNode" presStyleCnt="0"/>
      <dgm:spPr/>
    </dgm:pt>
    <dgm:pt modelId="{09823FA7-EE6D-4DAE-ADD2-F4E389899E8D}" type="pres">
      <dgm:prSet presAssocID="{D3960BAD-EC9F-4A2A-98F7-5FD1044001AD}" presName="parentText" presStyleLbl="node1" presStyleIdx="1" presStyleCnt="6">
        <dgm:presLayoutVars>
          <dgm:chMax val="1"/>
          <dgm:bulletEnabled val="1"/>
        </dgm:presLayoutVars>
      </dgm:prSet>
      <dgm:spPr/>
    </dgm:pt>
    <dgm:pt modelId="{57C50D58-E5E9-4261-85AB-98C75E93B30C}" type="pres">
      <dgm:prSet presAssocID="{0CD14DCE-6BBE-4E98-B1FC-DB7D09CF0691}" presName="sp" presStyleCnt="0"/>
      <dgm:spPr/>
    </dgm:pt>
    <dgm:pt modelId="{12F36334-962A-4CDC-B84F-B40B9A60BE03}" type="pres">
      <dgm:prSet presAssocID="{76DBA1F2-425C-43CF-913C-E4BDDB1AE249}" presName="linNode" presStyleCnt="0"/>
      <dgm:spPr/>
    </dgm:pt>
    <dgm:pt modelId="{F02E4B4A-376F-4589-891C-39658BC12E26}" type="pres">
      <dgm:prSet presAssocID="{76DBA1F2-425C-43CF-913C-E4BDDB1AE249}" presName="parentText" presStyleLbl="node1" presStyleIdx="2" presStyleCnt="6">
        <dgm:presLayoutVars>
          <dgm:chMax val="1"/>
          <dgm:bulletEnabled val="1"/>
        </dgm:presLayoutVars>
      </dgm:prSet>
      <dgm:spPr/>
    </dgm:pt>
    <dgm:pt modelId="{78ECEA7E-1400-4AFF-B898-CC65F43BF8DC}" type="pres">
      <dgm:prSet presAssocID="{AD1EFCB2-3F22-42BA-A58A-FB4EA30F9247}" presName="sp" presStyleCnt="0"/>
      <dgm:spPr/>
    </dgm:pt>
    <dgm:pt modelId="{6AFB94C5-E728-4CED-A8A0-958774F27D83}" type="pres">
      <dgm:prSet presAssocID="{B47BCCA7-A393-48E7-B26C-02E9E6E42220}" presName="linNode" presStyleCnt="0"/>
      <dgm:spPr/>
    </dgm:pt>
    <dgm:pt modelId="{D4ABB1F0-14F4-42E2-B03C-8669D9E40232}" type="pres">
      <dgm:prSet presAssocID="{B47BCCA7-A393-48E7-B26C-02E9E6E42220}" presName="parentText" presStyleLbl="node1" presStyleIdx="3" presStyleCnt="6">
        <dgm:presLayoutVars>
          <dgm:chMax val="1"/>
          <dgm:bulletEnabled val="1"/>
        </dgm:presLayoutVars>
      </dgm:prSet>
      <dgm:spPr/>
    </dgm:pt>
    <dgm:pt modelId="{2E78CB72-2C4A-466B-BD5A-A527AED8F863}" type="pres">
      <dgm:prSet presAssocID="{40E0607F-2AC8-4B55-8AF4-64DBB11E27AE}" presName="sp" presStyleCnt="0"/>
      <dgm:spPr/>
    </dgm:pt>
    <dgm:pt modelId="{2EE9B4AB-D3A0-49E8-A6D8-1C670D1FBDAA}" type="pres">
      <dgm:prSet presAssocID="{6C903908-5B54-47E0-AD16-3AB79B184B38}" presName="linNode" presStyleCnt="0"/>
      <dgm:spPr/>
    </dgm:pt>
    <dgm:pt modelId="{FA241F88-A4DF-450A-A56D-58C5462F63A2}" type="pres">
      <dgm:prSet presAssocID="{6C903908-5B54-47E0-AD16-3AB79B184B38}" presName="parentText" presStyleLbl="node1" presStyleIdx="4" presStyleCnt="6">
        <dgm:presLayoutVars>
          <dgm:chMax val="1"/>
          <dgm:bulletEnabled val="1"/>
        </dgm:presLayoutVars>
      </dgm:prSet>
      <dgm:spPr/>
    </dgm:pt>
    <dgm:pt modelId="{359F814F-80FD-4D37-BFC8-8D2AB9663D5A}" type="pres">
      <dgm:prSet presAssocID="{BC488F05-C2DD-41A8-94EC-B03FB4A10803}" presName="sp" presStyleCnt="0"/>
      <dgm:spPr/>
    </dgm:pt>
    <dgm:pt modelId="{B29CBD4B-B560-46FE-ABCD-2E8209013FED}" type="pres">
      <dgm:prSet presAssocID="{26B6E8F3-4A91-4E8A-873F-BC8C1BB8C749}" presName="linNode" presStyleCnt="0"/>
      <dgm:spPr/>
    </dgm:pt>
    <dgm:pt modelId="{41E3352D-5E3F-43FD-B627-E25BACBFD1E3}" type="pres">
      <dgm:prSet presAssocID="{26B6E8F3-4A91-4E8A-873F-BC8C1BB8C749}" presName="parentText" presStyleLbl="node1" presStyleIdx="5" presStyleCnt="6">
        <dgm:presLayoutVars>
          <dgm:chMax val="1"/>
          <dgm:bulletEnabled val="1"/>
        </dgm:presLayoutVars>
      </dgm:prSet>
      <dgm:spPr/>
    </dgm:pt>
  </dgm:ptLst>
  <dgm:cxnLst>
    <dgm:cxn modelId="{80DB3209-7EED-48D9-BA10-997BC00AF3A1}" srcId="{91F3F582-8660-4E2F-B97E-683EEC240E3D}" destId="{FDAB2C87-7C26-40D6-896E-3F76556EBE39}" srcOrd="0" destOrd="0" parTransId="{3273BE2E-782C-47F9-ADB9-30D85A17ED5E}" sibTransId="{87E73D53-D5D7-48F4-96ED-37E9FFF949E8}"/>
    <dgm:cxn modelId="{08C7BA19-D576-4B14-AC7A-F53F5F57B7EF}" type="presOf" srcId="{91F3F582-8660-4E2F-B97E-683EEC240E3D}" destId="{C4627956-46C1-4C9C-862F-D632754C713D}" srcOrd="0" destOrd="0" presId="urn:microsoft.com/office/officeart/2005/8/layout/vList5"/>
    <dgm:cxn modelId="{8F5B0B1F-AD28-49A1-BC18-CDA43607EEFA}" srcId="{91F3F582-8660-4E2F-B97E-683EEC240E3D}" destId="{B47BCCA7-A393-48E7-B26C-02E9E6E42220}" srcOrd="3" destOrd="0" parTransId="{E1E6ADE2-45D3-42E0-BEE8-5F460D8E1F47}" sibTransId="{40E0607F-2AC8-4B55-8AF4-64DBB11E27AE}"/>
    <dgm:cxn modelId="{B46A325B-3DCA-471F-AC8C-1A818322E963}" type="presOf" srcId="{FDAB2C87-7C26-40D6-896E-3F76556EBE39}" destId="{20BEAB21-ADCA-4148-931A-9126F5F5038D}" srcOrd="0" destOrd="0" presId="urn:microsoft.com/office/officeart/2005/8/layout/vList5"/>
    <dgm:cxn modelId="{EF23C948-17AB-4F06-9A0A-12EBC3C02C00}" srcId="{91F3F582-8660-4E2F-B97E-683EEC240E3D}" destId="{6C903908-5B54-47E0-AD16-3AB79B184B38}" srcOrd="4" destOrd="0" parTransId="{CB48CC08-05E1-475A-87D9-C000AD6DDD6F}" sibTransId="{BC488F05-C2DD-41A8-94EC-B03FB4A10803}"/>
    <dgm:cxn modelId="{13CB2C69-89B8-4BBA-91A3-58DAB0B5CDA7}" srcId="{91F3F582-8660-4E2F-B97E-683EEC240E3D}" destId="{76DBA1F2-425C-43CF-913C-E4BDDB1AE249}" srcOrd="2" destOrd="0" parTransId="{50102F50-0051-4165-8199-A69C0A61F220}" sibTransId="{AD1EFCB2-3F22-42BA-A58A-FB4EA30F9247}"/>
    <dgm:cxn modelId="{F1573093-349E-4B6E-9004-530A2AB94AFB}" srcId="{91F3F582-8660-4E2F-B97E-683EEC240E3D}" destId="{D3960BAD-EC9F-4A2A-98F7-5FD1044001AD}" srcOrd="1" destOrd="0" parTransId="{BB51419B-3375-4C32-BAC8-69A1E85FF5B3}" sibTransId="{0CD14DCE-6BBE-4E98-B1FC-DB7D09CF0691}"/>
    <dgm:cxn modelId="{AE0AB898-343C-4467-862F-5884F443FD17}" type="presOf" srcId="{D3960BAD-EC9F-4A2A-98F7-5FD1044001AD}" destId="{09823FA7-EE6D-4DAE-ADD2-F4E389899E8D}" srcOrd="0" destOrd="0" presId="urn:microsoft.com/office/officeart/2005/8/layout/vList5"/>
    <dgm:cxn modelId="{49A674B5-83E1-4248-A542-25608675CEE3}" srcId="{91F3F582-8660-4E2F-B97E-683EEC240E3D}" destId="{26B6E8F3-4A91-4E8A-873F-BC8C1BB8C749}" srcOrd="5" destOrd="0" parTransId="{04BE29CB-1DBB-4ACC-906C-773A29269557}" sibTransId="{872B72EA-FA56-4763-97CD-4F1B6E37F102}"/>
    <dgm:cxn modelId="{3B647BB6-858D-42CC-8238-596B6F11BCBC}" type="presOf" srcId="{26B6E8F3-4A91-4E8A-873F-BC8C1BB8C749}" destId="{41E3352D-5E3F-43FD-B627-E25BACBFD1E3}" srcOrd="0" destOrd="0" presId="urn:microsoft.com/office/officeart/2005/8/layout/vList5"/>
    <dgm:cxn modelId="{D91091D6-7814-4E95-BC56-B168B730E167}" type="presOf" srcId="{B47BCCA7-A393-48E7-B26C-02E9E6E42220}" destId="{D4ABB1F0-14F4-42E2-B03C-8669D9E40232}" srcOrd="0" destOrd="0" presId="urn:microsoft.com/office/officeart/2005/8/layout/vList5"/>
    <dgm:cxn modelId="{B31F34E0-3904-469E-AAD4-716C07B39ECB}" type="presOf" srcId="{76DBA1F2-425C-43CF-913C-E4BDDB1AE249}" destId="{F02E4B4A-376F-4589-891C-39658BC12E26}" srcOrd="0" destOrd="0" presId="urn:microsoft.com/office/officeart/2005/8/layout/vList5"/>
    <dgm:cxn modelId="{1265D1EB-E96F-4A35-8680-59BAAD63DFF2}" type="presOf" srcId="{6C903908-5B54-47E0-AD16-3AB79B184B38}" destId="{FA241F88-A4DF-450A-A56D-58C5462F63A2}" srcOrd="0" destOrd="0" presId="urn:microsoft.com/office/officeart/2005/8/layout/vList5"/>
    <dgm:cxn modelId="{4ED4B68E-4F1D-479E-9F51-4FE4E93666A6}" type="presParOf" srcId="{C4627956-46C1-4C9C-862F-D632754C713D}" destId="{C6BD7D8A-4FAC-47FD-BCAC-A732E04FF69B}" srcOrd="0" destOrd="0" presId="urn:microsoft.com/office/officeart/2005/8/layout/vList5"/>
    <dgm:cxn modelId="{91A7409D-143B-4A76-832A-74D83A322095}" type="presParOf" srcId="{C6BD7D8A-4FAC-47FD-BCAC-A732E04FF69B}" destId="{20BEAB21-ADCA-4148-931A-9126F5F5038D}" srcOrd="0" destOrd="0" presId="urn:microsoft.com/office/officeart/2005/8/layout/vList5"/>
    <dgm:cxn modelId="{BBB335F8-B085-4CFD-81B4-B759E59D8676}" type="presParOf" srcId="{C4627956-46C1-4C9C-862F-D632754C713D}" destId="{AD76DBB9-BF65-46EC-B7F8-5215118C7379}" srcOrd="1" destOrd="0" presId="urn:microsoft.com/office/officeart/2005/8/layout/vList5"/>
    <dgm:cxn modelId="{8A644085-8E53-4608-AFE3-A223176AF26A}" type="presParOf" srcId="{C4627956-46C1-4C9C-862F-D632754C713D}" destId="{698F7748-C46E-4397-801C-7C43FD66735B}" srcOrd="2" destOrd="0" presId="urn:microsoft.com/office/officeart/2005/8/layout/vList5"/>
    <dgm:cxn modelId="{5AE5274D-CCB3-4E4E-8148-AFE7B1F65D89}" type="presParOf" srcId="{698F7748-C46E-4397-801C-7C43FD66735B}" destId="{09823FA7-EE6D-4DAE-ADD2-F4E389899E8D}" srcOrd="0" destOrd="0" presId="urn:microsoft.com/office/officeart/2005/8/layout/vList5"/>
    <dgm:cxn modelId="{697ADDFE-2B62-44B9-B115-F1938E567655}" type="presParOf" srcId="{C4627956-46C1-4C9C-862F-D632754C713D}" destId="{57C50D58-E5E9-4261-85AB-98C75E93B30C}" srcOrd="3" destOrd="0" presId="urn:microsoft.com/office/officeart/2005/8/layout/vList5"/>
    <dgm:cxn modelId="{588C8958-BED1-405B-8B6F-25FB042EBF81}" type="presParOf" srcId="{C4627956-46C1-4C9C-862F-D632754C713D}" destId="{12F36334-962A-4CDC-B84F-B40B9A60BE03}" srcOrd="4" destOrd="0" presId="urn:microsoft.com/office/officeart/2005/8/layout/vList5"/>
    <dgm:cxn modelId="{8579B8D9-EBBF-48CA-80AE-4193CBBD12F9}" type="presParOf" srcId="{12F36334-962A-4CDC-B84F-B40B9A60BE03}" destId="{F02E4B4A-376F-4589-891C-39658BC12E26}" srcOrd="0" destOrd="0" presId="urn:microsoft.com/office/officeart/2005/8/layout/vList5"/>
    <dgm:cxn modelId="{FD5A80FD-AA9C-4BDD-B964-7799EBD7784B}" type="presParOf" srcId="{C4627956-46C1-4C9C-862F-D632754C713D}" destId="{78ECEA7E-1400-4AFF-B898-CC65F43BF8DC}" srcOrd="5" destOrd="0" presId="urn:microsoft.com/office/officeart/2005/8/layout/vList5"/>
    <dgm:cxn modelId="{4055CA50-649A-4198-B0AC-147AD26B96A9}" type="presParOf" srcId="{C4627956-46C1-4C9C-862F-D632754C713D}" destId="{6AFB94C5-E728-4CED-A8A0-958774F27D83}" srcOrd="6" destOrd="0" presId="urn:microsoft.com/office/officeart/2005/8/layout/vList5"/>
    <dgm:cxn modelId="{0362E2CD-D3A3-41D5-9788-C2EA9315EBE4}" type="presParOf" srcId="{6AFB94C5-E728-4CED-A8A0-958774F27D83}" destId="{D4ABB1F0-14F4-42E2-B03C-8669D9E40232}" srcOrd="0" destOrd="0" presId="urn:microsoft.com/office/officeart/2005/8/layout/vList5"/>
    <dgm:cxn modelId="{78330903-5738-47C8-98AD-62D79DC24AD4}" type="presParOf" srcId="{C4627956-46C1-4C9C-862F-D632754C713D}" destId="{2E78CB72-2C4A-466B-BD5A-A527AED8F863}" srcOrd="7" destOrd="0" presId="urn:microsoft.com/office/officeart/2005/8/layout/vList5"/>
    <dgm:cxn modelId="{15B64048-9374-4934-9B24-3935638D4FE3}" type="presParOf" srcId="{C4627956-46C1-4C9C-862F-D632754C713D}" destId="{2EE9B4AB-D3A0-49E8-A6D8-1C670D1FBDAA}" srcOrd="8" destOrd="0" presId="urn:microsoft.com/office/officeart/2005/8/layout/vList5"/>
    <dgm:cxn modelId="{77E33A1E-C141-4409-90F3-C0900536AE20}" type="presParOf" srcId="{2EE9B4AB-D3A0-49E8-A6D8-1C670D1FBDAA}" destId="{FA241F88-A4DF-450A-A56D-58C5462F63A2}" srcOrd="0" destOrd="0" presId="urn:microsoft.com/office/officeart/2005/8/layout/vList5"/>
    <dgm:cxn modelId="{B60F22BB-E6BF-409C-AC26-B18151AB0492}" type="presParOf" srcId="{C4627956-46C1-4C9C-862F-D632754C713D}" destId="{359F814F-80FD-4D37-BFC8-8D2AB9663D5A}" srcOrd="9" destOrd="0" presId="urn:microsoft.com/office/officeart/2005/8/layout/vList5"/>
    <dgm:cxn modelId="{A536DCEF-911B-42AD-9E5C-7599E428BD81}" type="presParOf" srcId="{C4627956-46C1-4C9C-862F-D632754C713D}" destId="{B29CBD4B-B560-46FE-ABCD-2E8209013FED}" srcOrd="10" destOrd="0" presId="urn:microsoft.com/office/officeart/2005/8/layout/vList5"/>
    <dgm:cxn modelId="{D58141CE-3940-4982-8262-84EEAAEB92B9}" type="presParOf" srcId="{B29CBD4B-B560-46FE-ABCD-2E8209013FED}" destId="{41E3352D-5E3F-43FD-B627-E25BACBFD1E3}" srcOrd="0" destOrd="0" presId="urn:microsoft.com/office/officeart/2005/8/layout/vList5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1F3F582-8660-4E2F-B97E-683EEC240E3D}" type="doc">
      <dgm:prSet loTypeId="urn:microsoft.com/office/officeart/2005/8/layout/vList5" loCatId="list" qsTypeId="urn:microsoft.com/office/officeart/2005/8/quickstyle/simple3" qsCatId="simple" csTypeId="urn:microsoft.com/office/officeart/2005/8/colors/accent1_3" csCatId="accent1" phldr="1"/>
      <dgm:spPr/>
    </dgm:pt>
    <dgm:pt modelId="{D3960BAD-EC9F-4A2A-98F7-5FD1044001AD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,413 proteins</a:t>
          </a:r>
          <a:endParaRPr lang="de-DE" b="1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B51419B-3375-4C32-BAC8-69A1E85FF5B3}" type="parTrans" cxnId="{F1573093-349E-4B6E-9004-530A2AB94AFB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0CD14DCE-6BBE-4E98-B1FC-DB7D09CF0691}" type="sibTrans" cxnId="{F1573093-349E-4B6E-9004-530A2AB94AFB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76DBA1F2-425C-43CF-913C-E4BDDB1AE249}">
      <dgm:prSet phldrT="[Text]"/>
      <dgm:spPr/>
      <dgm:t>
        <a:bodyPr anchor="t"/>
        <a:lstStyle/>
        <a:p>
          <a:r>
            <a:rPr lang="en-US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5 </a:t>
          </a:r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proteins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 with more than 25% of values below the limit of detection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50102F50-0051-4165-8199-A69C0A61F220}" type="parTrans" cxnId="{13CB2C69-89B8-4BBA-91A3-58DAB0B5CDA7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AD1EFCB2-3F22-42BA-A58A-FB4EA30F9247}" type="sibTrans" cxnId="{13CB2C69-89B8-4BBA-91A3-58DAB0B5CDA7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47BCCA7-A393-48E7-B26C-02E9E6E42220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10 proteins 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more than 20% missing data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E1E6ADE2-45D3-42E0-BEE8-5F460D8E1F47}" type="parTrans" cxnId="{8F5B0B1F-AD28-49A1-BC18-CDA43607EEFA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40E0607F-2AC8-4B55-8AF4-64DBB11E27AE}" type="sibTrans" cxnId="{8F5B0B1F-AD28-49A1-BC18-CDA43607EEFA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6C903908-5B54-47E0-AD16-3AB79B184B38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10 proteins </a:t>
          </a:r>
        </a:p>
        <a:p>
          <a:r>
            <a:rPr lang="en-GB" b="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highly skewed* distribution</a:t>
          </a:r>
          <a:endParaRPr lang="de-DE" b="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CB48CC08-05E1-475A-87D9-C000AD6DDD6F}" type="parTrans" cxnId="{EF23C948-17AB-4F06-9A0A-12EBC3C02C00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BC488F05-C2DD-41A8-94EC-B03FB4A10803}" type="sibTrans" cxnId="{EF23C948-17AB-4F06-9A0A-12EBC3C02C00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26B6E8F3-4A91-4E8A-873F-BC8C1BB8C749}">
      <dgm:prSet phldrT="[Text]"/>
      <dgm:spPr/>
      <dgm:t>
        <a:bodyPr anchor="t"/>
        <a:lstStyle/>
        <a:p>
          <a:r>
            <a:rPr lang="en-GB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,368 proteins</a:t>
          </a:r>
          <a:endParaRPr lang="de-DE" b="1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04BE29CB-1DBB-4ACC-906C-773A29269557}" type="parTrans" cxnId="{49A674B5-83E1-4248-A542-25608675CEE3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872B72EA-FA56-4763-97CD-4F1B6E37F102}" type="sibTrans" cxnId="{49A674B5-83E1-4248-A542-25608675CEE3}">
      <dgm:prSet/>
      <dgm:spPr/>
      <dgm:t>
        <a:bodyPr/>
        <a:lstStyle/>
        <a:p>
          <a:endParaRPr lang="de-DE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gm:t>
    </dgm:pt>
    <dgm:pt modelId="{5EA98763-D5A6-4F6A-AD29-5CE8C3508228}">
      <dgm:prSet phldrT="[Text]"/>
      <dgm:spPr/>
      <dgm:t>
        <a:bodyPr anchor="t"/>
        <a:lstStyle/>
        <a:p>
          <a:r>
            <a:rPr lang="de-D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ESTHER </a:t>
          </a:r>
        </a:p>
        <a:p>
          <a:r>
            <a:rPr lang="de-DE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Olink Explore HT</a:t>
          </a:r>
        </a:p>
      </dgm:t>
    </dgm:pt>
    <dgm:pt modelId="{C8E33121-ABCE-429C-8E71-AD23B1E7CDC7}" type="parTrans" cxnId="{854B7ECC-B61C-43CA-BFE5-A0C72E436D33}">
      <dgm:prSet/>
      <dgm:spPr/>
      <dgm:t>
        <a:bodyPr/>
        <a:lstStyle/>
        <a:p>
          <a:endParaRPr lang="de-DE"/>
        </a:p>
      </dgm:t>
    </dgm:pt>
    <dgm:pt modelId="{A7113024-D3D3-4CE6-9F28-A53C4B368A50}" type="sibTrans" cxnId="{854B7ECC-B61C-43CA-BFE5-A0C72E436D33}">
      <dgm:prSet/>
      <dgm:spPr/>
      <dgm:t>
        <a:bodyPr/>
        <a:lstStyle/>
        <a:p>
          <a:endParaRPr lang="de-DE"/>
        </a:p>
      </dgm:t>
    </dgm:pt>
    <dgm:pt modelId="{C4627956-46C1-4C9C-862F-D632754C713D}" type="pres">
      <dgm:prSet presAssocID="{91F3F582-8660-4E2F-B97E-683EEC240E3D}" presName="Name0" presStyleCnt="0">
        <dgm:presLayoutVars>
          <dgm:dir/>
          <dgm:animLvl val="lvl"/>
          <dgm:resizeHandles val="exact"/>
        </dgm:presLayoutVars>
      </dgm:prSet>
      <dgm:spPr/>
    </dgm:pt>
    <dgm:pt modelId="{D1BFB351-BC0A-4EC3-9147-253ED9B8AB45}" type="pres">
      <dgm:prSet presAssocID="{5EA98763-D5A6-4F6A-AD29-5CE8C3508228}" presName="linNode" presStyleCnt="0"/>
      <dgm:spPr/>
    </dgm:pt>
    <dgm:pt modelId="{1BECA0BA-FD9C-4CF8-827A-A5AB48031D3A}" type="pres">
      <dgm:prSet presAssocID="{5EA98763-D5A6-4F6A-AD29-5CE8C3508228}" presName="parentText" presStyleLbl="node1" presStyleIdx="0" presStyleCnt="6">
        <dgm:presLayoutVars>
          <dgm:chMax val="1"/>
          <dgm:bulletEnabled val="1"/>
        </dgm:presLayoutVars>
      </dgm:prSet>
      <dgm:spPr/>
    </dgm:pt>
    <dgm:pt modelId="{B070C0CD-547C-4207-8A51-E0310D63D6E9}" type="pres">
      <dgm:prSet presAssocID="{A7113024-D3D3-4CE6-9F28-A53C4B368A50}" presName="sp" presStyleCnt="0"/>
      <dgm:spPr/>
    </dgm:pt>
    <dgm:pt modelId="{698F7748-C46E-4397-801C-7C43FD66735B}" type="pres">
      <dgm:prSet presAssocID="{D3960BAD-EC9F-4A2A-98F7-5FD1044001AD}" presName="linNode" presStyleCnt="0"/>
      <dgm:spPr/>
    </dgm:pt>
    <dgm:pt modelId="{09823FA7-EE6D-4DAE-ADD2-F4E389899E8D}" type="pres">
      <dgm:prSet presAssocID="{D3960BAD-EC9F-4A2A-98F7-5FD1044001AD}" presName="parentText" presStyleLbl="node1" presStyleIdx="1" presStyleCnt="6">
        <dgm:presLayoutVars>
          <dgm:chMax val="1"/>
          <dgm:bulletEnabled val="1"/>
        </dgm:presLayoutVars>
      </dgm:prSet>
      <dgm:spPr/>
    </dgm:pt>
    <dgm:pt modelId="{57C50D58-E5E9-4261-85AB-98C75E93B30C}" type="pres">
      <dgm:prSet presAssocID="{0CD14DCE-6BBE-4E98-B1FC-DB7D09CF0691}" presName="sp" presStyleCnt="0"/>
      <dgm:spPr/>
    </dgm:pt>
    <dgm:pt modelId="{12F36334-962A-4CDC-B84F-B40B9A60BE03}" type="pres">
      <dgm:prSet presAssocID="{76DBA1F2-425C-43CF-913C-E4BDDB1AE249}" presName="linNode" presStyleCnt="0"/>
      <dgm:spPr/>
    </dgm:pt>
    <dgm:pt modelId="{F02E4B4A-376F-4589-891C-39658BC12E26}" type="pres">
      <dgm:prSet presAssocID="{76DBA1F2-425C-43CF-913C-E4BDDB1AE249}" presName="parentText" presStyleLbl="node1" presStyleIdx="2" presStyleCnt="6">
        <dgm:presLayoutVars>
          <dgm:chMax val="1"/>
          <dgm:bulletEnabled val="1"/>
        </dgm:presLayoutVars>
      </dgm:prSet>
      <dgm:spPr/>
    </dgm:pt>
    <dgm:pt modelId="{78ECEA7E-1400-4AFF-B898-CC65F43BF8DC}" type="pres">
      <dgm:prSet presAssocID="{AD1EFCB2-3F22-42BA-A58A-FB4EA30F9247}" presName="sp" presStyleCnt="0"/>
      <dgm:spPr/>
    </dgm:pt>
    <dgm:pt modelId="{6AFB94C5-E728-4CED-A8A0-958774F27D83}" type="pres">
      <dgm:prSet presAssocID="{B47BCCA7-A393-48E7-B26C-02E9E6E42220}" presName="linNode" presStyleCnt="0"/>
      <dgm:spPr/>
    </dgm:pt>
    <dgm:pt modelId="{D4ABB1F0-14F4-42E2-B03C-8669D9E40232}" type="pres">
      <dgm:prSet presAssocID="{B47BCCA7-A393-48E7-B26C-02E9E6E42220}" presName="parentText" presStyleLbl="node1" presStyleIdx="3" presStyleCnt="6">
        <dgm:presLayoutVars>
          <dgm:chMax val="1"/>
          <dgm:bulletEnabled val="1"/>
        </dgm:presLayoutVars>
      </dgm:prSet>
      <dgm:spPr/>
    </dgm:pt>
    <dgm:pt modelId="{2E78CB72-2C4A-466B-BD5A-A527AED8F863}" type="pres">
      <dgm:prSet presAssocID="{40E0607F-2AC8-4B55-8AF4-64DBB11E27AE}" presName="sp" presStyleCnt="0"/>
      <dgm:spPr/>
    </dgm:pt>
    <dgm:pt modelId="{2EE9B4AB-D3A0-49E8-A6D8-1C670D1FBDAA}" type="pres">
      <dgm:prSet presAssocID="{6C903908-5B54-47E0-AD16-3AB79B184B38}" presName="linNode" presStyleCnt="0"/>
      <dgm:spPr/>
    </dgm:pt>
    <dgm:pt modelId="{FA241F88-A4DF-450A-A56D-58C5462F63A2}" type="pres">
      <dgm:prSet presAssocID="{6C903908-5B54-47E0-AD16-3AB79B184B38}" presName="parentText" presStyleLbl="node1" presStyleIdx="4" presStyleCnt="6">
        <dgm:presLayoutVars>
          <dgm:chMax val="1"/>
          <dgm:bulletEnabled val="1"/>
        </dgm:presLayoutVars>
      </dgm:prSet>
      <dgm:spPr/>
    </dgm:pt>
    <dgm:pt modelId="{359F814F-80FD-4D37-BFC8-8D2AB9663D5A}" type="pres">
      <dgm:prSet presAssocID="{BC488F05-C2DD-41A8-94EC-B03FB4A10803}" presName="sp" presStyleCnt="0"/>
      <dgm:spPr/>
    </dgm:pt>
    <dgm:pt modelId="{B29CBD4B-B560-46FE-ABCD-2E8209013FED}" type="pres">
      <dgm:prSet presAssocID="{26B6E8F3-4A91-4E8A-873F-BC8C1BB8C749}" presName="linNode" presStyleCnt="0"/>
      <dgm:spPr/>
    </dgm:pt>
    <dgm:pt modelId="{41E3352D-5E3F-43FD-B627-E25BACBFD1E3}" type="pres">
      <dgm:prSet presAssocID="{26B6E8F3-4A91-4E8A-873F-BC8C1BB8C749}" presName="parentText" presStyleLbl="node1" presStyleIdx="5" presStyleCnt="6">
        <dgm:presLayoutVars>
          <dgm:chMax val="1"/>
          <dgm:bulletEnabled val="1"/>
        </dgm:presLayoutVars>
      </dgm:prSet>
      <dgm:spPr/>
    </dgm:pt>
  </dgm:ptLst>
  <dgm:cxnLst>
    <dgm:cxn modelId="{08C7BA19-D576-4B14-AC7A-F53F5F57B7EF}" type="presOf" srcId="{91F3F582-8660-4E2F-B97E-683EEC240E3D}" destId="{C4627956-46C1-4C9C-862F-D632754C713D}" srcOrd="0" destOrd="0" presId="urn:microsoft.com/office/officeart/2005/8/layout/vList5"/>
    <dgm:cxn modelId="{8F5B0B1F-AD28-49A1-BC18-CDA43607EEFA}" srcId="{91F3F582-8660-4E2F-B97E-683EEC240E3D}" destId="{B47BCCA7-A393-48E7-B26C-02E9E6E42220}" srcOrd="3" destOrd="0" parTransId="{E1E6ADE2-45D3-42E0-BEE8-5F460D8E1F47}" sibTransId="{40E0607F-2AC8-4B55-8AF4-64DBB11E27AE}"/>
    <dgm:cxn modelId="{EF23C948-17AB-4F06-9A0A-12EBC3C02C00}" srcId="{91F3F582-8660-4E2F-B97E-683EEC240E3D}" destId="{6C903908-5B54-47E0-AD16-3AB79B184B38}" srcOrd="4" destOrd="0" parTransId="{CB48CC08-05E1-475A-87D9-C000AD6DDD6F}" sibTransId="{BC488F05-C2DD-41A8-94EC-B03FB4A10803}"/>
    <dgm:cxn modelId="{13CB2C69-89B8-4BBA-91A3-58DAB0B5CDA7}" srcId="{91F3F582-8660-4E2F-B97E-683EEC240E3D}" destId="{76DBA1F2-425C-43CF-913C-E4BDDB1AE249}" srcOrd="2" destOrd="0" parTransId="{50102F50-0051-4165-8199-A69C0A61F220}" sibTransId="{AD1EFCB2-3F22-42BA-A58A-FB4EA30F9247}"/>
    <dgm:cxn modelId="{F1573093-349E-4B6E-9004-530A2AB94AFB}" srcId="{91F3F582-8660-4E2F-B97E-683EEC240E3D}" destId="{D3960BAD-EC9F-4A2A-98F7-5FD1044001AD}" srcOrd="1" destOrd="0" parTransId="{BB51419B-3375-4C32-BAC8-69A1E85FF5B3}" sibTransId="{0CD14DCE-6BBE-4E98-B1FC-DB7D09CF0691}"/>
    <dgm:cxn modelId="{AE0AB898-343C-4467-862F-5884F443FD17}" type="presOf" srcId="{D3960BAD-EC9F-4A2A-98F7-5FD1044001AD}" destId="{09823FA7-EE6D-4DAE-ADD2-F4E389899E8D}" srcOrd="0" destOrd="0" presId="urn:microsoft.com/office/officeart/2005/8/layout/vList5"/>
    <dgm:cxn modelId="{D41D7E9D-E459-43F2-BA78-1477A68FA585}" type="presOf" srcId="{5EA98763-D5A6-4F6A-AD29-5CE8C3508228}" destId="{1BECA0BA-FD9C-4CF8-827A-A5AB48031D3A}" srcOrd="0" destOrd="0" presId="urn:microsoft.com/office/officeart/2005/8/layout/vList5"/>
    <dgm:cxn modelId="{49A674B5-83E1-4248-A542-25608675CEE3}" srcId="{91F3F582-8660-4E2F-B97E-683EEC240E3D}" destId="{26B6E8F3-4A91-4E8A-873F-BC8C1BB8C749}" srcOrd="5" destOrd="0" parTransId="{04BE29CB-1DBB-4ACC-906C-773A29269557}" sibTransId="{872B72EA-FA56-4763-97CD-4F1B6E37F102}"/>
    <dgm:cxn modelId="{3B647BB6-858D-42CC-8238-596B6F11BCBC}" type="presOf" srcId="{26B6E8F3-4A91-4E8A-873F-BC8C1BB8C749}" destId="{41E3352D-5E3F-43FD-B627-E25BACBFD1E3}" srcOrd="0" destOrd="0" presId="urn:microsoft.com/office/officeart/2005/8/layout/vList5"/>
    <dgm:cxn modelId="{854B7ECC-B61C-43CA-BFE5-A0C72E436D33}" srcId="{91F3F582-8660-4E2F-B97E-683EEC240E3D}" destId="{5EA98763-D5A6-4F6A-AD29-5CE8C3508228}" srcOrd="0" destOrd="0" parTransId="{C8E33121-ABCE-429C-8E71-AD23B1E7CDC7}" sibTransId="{A7113024-D3D3-4CE6-9F28-A53C4B368A50}"/>
    <dgm:cxn modelId="{D91091D6-7814-4E95-BC56-B168B730E167}" type="presOf" srcId="{B47BCCA7-A393-48E7-B26C-02E9E6E42220}" destId="{D4ABB1F0-14F4-42E2-B03C-8669D9E40232}" srcOrd="0" destOrd="0" presId="urn:microsoft.com/office/officeart/2005/8/layout/vList5"/>
    <dgm:cxn modelId="{B31F34E0-3904-469E-AAD4-716C07B39ECB}" type="presOf" srcId="{76DBA1F2-425C-43CF-913C-E4BDDB1AE249}" destId="{F02E4B4A-376F-4589-891C-39658BC12E26}" srcOrd="0" destOrd="0" presId="urn:microsoft.com/office/officeart/2005/8/layout/vList5"/>
    <dgm:cxn modelId="{1265D1EB-E96F-4A35-8680-59BAAD63DFF2}" type="presOf" srcId="{6C903908-5B54-47E0-AD16-3AB79B184B38}" destId="{FA241F88-A4DF-450A-A56D-58C5462F63A2}" srcOrd="0" destOrd="0" presId="urn:microsoft.com/office/officeart/2005/8/layout/vList5"/>
    <dgm:cxn modelId="{48C323F1-08AE-4CB1-81A1-307C1605F1F1}" type="presParOf" srcId="{C4627956-46C1-4C9C-862F-D632754C713D}" destId="{D1BFB351-BC0A-4EC3-9147-253ED9B8AB45}" srcOrd="0" destOrd="0" presId="urn:microsoft.com/office/officeart/2005/8/layout/vList5"/>
    <dgm:cxn modelId="{013E0C42-8486-4F28-94B9-AADC629827B1}" type="presParOf" srcId="{D1BFB351-BC0A-4EC3-9147-253ED9B8AB45}" destId="{1BECA0BA-FD9C-4CF8-827A-A5AB48031D3A}" srcOrd="0" destOrd="0" presId="urn:microsoft.com/office/officeart/2005/8/layout/vList5"/>
    <dgm:cxn modelId="{F2548640-81D2-48B8-AF78-7D39CEC9A0A3}" type="presParOf" srcId="{C4627956-46C1-4C9C-862F-D632754C713D}" destId="{B070C0CD-547C-4207-8A51-E0310D63D6E9}" srcOrd="1" destOrd="0" presId="urn:microsoft.com/office/officeart/2005/8/layout/vList5"/>
    <dgm:cxn modelId="{8A644085-8E53-4608-AFE3-A223176AF26A}" type="presParOf" srcId="{C4627956-46C1-4C9C-862F-D632754C713D}" destId="{698F7748-C46E-4397-801C-7C43FD66735B}" srcOrd="2" destOrd="0" presId="urn:microsoft.com/office/officeart/2005/8/layout/vList5"/>
    <dgm:cxn modelId="{5AE5274D-CCB3-4E4E-8148-AFE7B1F65D89}" type="presParOf" srcId="{698F7748-C46E-4397-801C-7C43FD66735B}" destId="{09823FA7-EE6D-4DAE-ADD2-F4E389899E8D}" srcOrd="0" destOrd="0" presId="urn:microsoft.com/office/officeart/2005/8/layout/vList5"/>
    <dgm:cxn modelId="{697ADDFE-2B62-44B9-B115-F1938E567655}" type="presParOf" srcId="{C4627956-46C1-4C9C-862F-D632754C713D}" destId="{57C50D58-E5E9-4261-85AB-98C75E93B30C}" srcOrd="3" destOrd="0" presId="urn:microsoft.com/office/officeart/2005/8/layout/vList5"/>
    <dgm:cxn modelId="{588C8958-BED1-405B-8B6F-25FB042EBF81}" type="presParOf" srcId="{C4627956-46C1-4C9C-862F-D632754C713D}" destId="{12F36334-962A-4CDC-B84F-B40B9A60BE03}" srcOrd="4" destOrd="0" presId="urn:microsoft.com/office/officeart/2005/8/layout/vList5"/>
    <dgm:cxn modelId="{8579B8D9-EBBF-48CA-80AE-4193CBBD12F9}" type="presParOf" srcId="{12F36334-962A-4CDC-B84F-B40B9A60BE03}" destId="{F02E4B4A-376F-4589-891C-39658BC12E26}" srcOrd="0" destOrd="0" presId="urn:microsoft.com/office/officeart/2005/8/layout/vList5"/>
    <dgm:cxn modelId="{FD5A80FD-AA9C-4BDD-B964-7799EBD7784B}" type="presParOf" srcId="{C4627956-46C1-4C9C-862F-D632754C713D}" destId="{78ECEA7E-1400-4AFF-B898-CC65F43BF8DC}" srcOrd="5" destOrd="0" presId="urn:microsoft.com/office/officeart/2005/8/layout/vList5"/>
    <dgm:cxn modelId="{4055CA50-649A-4198-B0AC-147AD26B96A9}" type="presParOf" srcId="{C4627956-46C1-4C9C-862F-D632754C713D}" destId="{6AFB94C5-E728-4CED-A8A0-958774F27D83}" srcOrd="6" destOrd="0" presId="urn:microsoft.com/office/officeart/2005/8/layout/vList5"/>
    <dgm:cxn modelId="{0362E2CD-D3A3-41D5-9788-C2EA9315EBE4}" type="presParOf" srcId="{6AFB94C5-E728-4CED-A8A0-958774F27D83}" destId="{D4ABB1F0-14F4-42E2-B03C-8669D9E40232}" srcOrd="0" destOrd="0" presId="urn:microsoft.com/office/officeart/2005/8/layout/vList5"/>
    <dgm:cxn modelId="{78330903-5738-47C8-98AD-62D79DC24AD4}" type="presParOf" srcId="{C4627956-46C1-4C9C-862F-D632754C713D}" destId="{2E78CB72-2C4A-466B-BD5A-A527AED8F863}" srcOrd="7" destOrd="0" presId="urn:microsoft.com/office/officeart/2005/8/layout/vList5"/>
    <dgm:cxn modelId="{15B64048-9374-4934-9B24-3935638D4FE3}" type="presParOf" srcId="{C4627956-46C1-4C9C-862F-D632754C713D}" destId="{2EE9B4AB-D3A0-49E8-A6D8-1C670D1FBDAA}" srcOrd="8" destOrd="0" presId="urn:microsoft.com/office/officeart/2005/8/layout/vList5"/>
    <dgm:cxn modelId="{77E33A1E-C141-4409-90F3-C0900536AE20}" type="presParOf" srcId="{2EE9B4AB-D3A0-49E8-A6D8-1C670D1FBDAA}" destId="{FA241F88-A4DF-450A-A56D-58C5462F63A2}" srcOrd="0" destOrd="0" presId="urn:microsoft.com/office/officeart/2005/8/layout/vList5"/>
    <dgm:cxn modelId="{B60F22BB-E6BF-409C-AC26-B18151AB0492}" type="presParOf" srcId="{C4627956-46C1-4C9C-862F-D632754C713D}" destId="{359F814F-80FD-4D37-BFC8-8D2AB9663D5A}" srcOrd="9" destOrd="0" presId="urn:microsoft.com/office/officeart/2005/8/layout/vList5"/>
    <dgm:cxn modelId="{A536DCEF-911B-42AD-9E5C-7599E428BD81}" type="presParOf" srcId="{C4627956-46C1-4C9C-862F-D632754C713D}" destId="{B29CBD4B-B560-46FE-ABCD-2E8209013FED}" srcOrd="10" destOrd="0" presId="urn:microsoft.com/office/officeart/2005/8/layout/vList5"/>
    <dgm:cxn modelId="{D58141CE-3940-4982-8262-84EEAAEB92B9}" type="presParOf" srcId="{B29CBD4B-B560-46FE-ABCD-2E8209013FED}" destId="{41E3352D-5E3F-43FD-B627-E25BACBFD1E3}" srcOrd="0" destOrd="0" presId="urn:microsoft.com/office/officeart/2005/8/layout/vList5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0BEAB21-ADCA-4148-931A-9126F5F5038D}">
      <dsp:nvSpPr>
        <dsp:cNvPr id="0" name=""/>
        <dsp:cNvSpPr/>
      </dsp:nvSpPr>
      <dsp:spPr>
        <a:xfrm>
          <a:off x="2886306" y="1151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UK Biobank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Olink Explore 3072</a:t>
          </a:r>
        </a:p>
      </dsp:txBody>
      <dsp:txXfrm>
        <a:off x="2919036" y="33881"/>
        <a:ext cx="3181634" cy="605020"/>
      </dsp:txXfrm>
    </dsp:sp>
    <dsp:sp modelId="{09823FA7-EE6D-4DAE-ADD2-F4E389899E8D}">
      <dsp:nvSpPr>
        <dsp:cNvPr id="0" name=""/>
        <dsp:cNvSpPr/>
      </dsp:nvSpPr>
      <dsp:spPr>
        <a:xfrm>
          <a:off x="2886306" y="705155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109120"/>
                <a:satOff val="-11378"/>
                <a:lumOff val="7644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109120"/>
                <a:satOff val="-11378"/>
                <a:lumOff val="7644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109120"/>
                <a:satOff val="-11378"/>
                <a:lumOff val="7644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,923 proteins</a:t>
          </a:r>
          <a:endParaRPr lang="de-DE" sz="1100" b="1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737885"/>
        <a:ext cx="3181634" cy="605020"/>
      </dsp:txXfrm>
    </dsp:sp>
    <dsp:sp modelId="{F02E4B4A-376F-4589-891C-39658BC12E26}">
      <dsp:nvSpPr>
        <dsp:cNvPr id="0" name=""/>
        <dsp:cNvSpPr/>
      </dsp:nvSpPr>
      <dsp:spPr>
        <a:xfrm>
          <a:off x="2886306" y="1409160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218239"/>
                <a:satOff val="-22757"/>
                <a:lumOff val="1528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218239"/>
                <a:satOff val="-22757"/>
                <a:lumOff val="1528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218239"/>
                <a:satOff val="-22757"/>
                <a:lumOff val="1528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825 </a:t>
          </a: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proteins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 with more than 25% of values below the limit of detection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1441890"/>
        <a:ext cx="3181634" cy="605020"/>
      </dsp:txXfrm>
    </dsp:sp>
    <dsp:sp modelId="{D4ABB1F0-14F4-42E2-B03C-8669D9E40232}">
      <dsp:nvSpPr>
        <dsp:cNvPr id="0" name=""/>
        <dsp:cNvSpPr/>
      </dsp:nvSpPr>
      <dsp:spPr>
        <a:xfrm>
          <a:off x="2886306" y="2113164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327359"/>
                <a:satOff val="-34135"/>
                <a:lumOff val="22933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327359"/>
                <a:satOff val="-34135"/>
                <a:lumOff val="22933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327359"/>
                <a:satOff val="-34135"/>
                <a:lumOff val="22933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8 proteins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more than 20% missing data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2145894"/>
        <a:ext cx="3181634" cy="605020"/>
      </dsp:txXfrm>
    </dsp:sp>
    <dsp:sp modelId="{FA241F88-A4DF-450A-A56D-58C5462F63A2}">
      <dsp:nvSpPr>
        <dsp:cNvPr id="0" name=""/>
        <dsp:cNvSpPr/>
      </dsp:nvSpPr>
      <dsp:spPr>
        <a:xfrm>
          <a:off x="2886306" y="2817168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436479"/>
                <a:satOff val="-45514"/>
                <a:lumOff val="30577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436479"/>
                <a:satOff val="-45514"/>
                <a:lumOff val="30577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436479"/>
                <a:satOff val="-45514"/>
                <a:lumOff val="30577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0 proteins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highly skewed* distribution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2849898"/>
        <a:ext cx="3181634" cy="605020"/>
      </dsp:txXfrm>
    </dsp:sp>
    <dsp:sp modelId="{41E3352D-5E3F-43FD-B627-E25BACBFD1E3}">
      <dsp:nvSpPr>
        <dsp:cNvPr id="0" name=""/>
        <dsp:cNvSpPr/>
      </dsp:nvSpPr>
      <dsp:spPr>
        <a:xfrm>
          <a:off x="2886306" y="3521173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545598"/>
                <a:satOff val="-56892"/>
                <a:lumOff val="38221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545598"/>
                <a:satOff val="-56892"/>
                <a:lumOff val="38221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545598"/>
                <a:satOff val="-56892"/>
                <a:lumOff val="38221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,040 proteins</a:t>
          </a:r>
          <a:endParaRPr lang="de-DE" sz="1100" b="1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3553903"/>
        <a:ext cx="3181634" cy="60502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BECA0BA-FD9C-4CF8-827A-A5AB48031D3A}">
      <dsp:nvSpPr>
        <dsp:cNvPr id="0" name=""/>
        <dsp:cNvSpPr/>
      </dsp:nvSpPr>
      <dsp:spPr>
        <a:xfrm>
          <a:off x="2886306" y="1151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ESTHER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Olink Explore HT</a:t>
          </a:r>
        </a:p>
      </dsp:txBody>
      <dsp:txXfrm>
        <a:off x="2919036" y="33881"/>
        <a:ext cx="3181634" cy="605020"/>
      </dsp:txXfrm>
    </dsp:sp>
    <dsp:sp modelId="{09823FA7-EE6D-4DAE-ADD2-F4E389899E8D}">
      <dsp:nvSpPr>
        <dsp:cNvPr id="0" name=""/>
        <dsp:cNvSpPr/>
      </dsp:nvSpPr>
      <dsp:spPr>
        <a:xfrm>
          <a:off x="2886306" y="705155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109120"/>
                <a:satOff val="-11378"/>
                <a:lumOff val="7644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109120"/>
                <a:satOff val="-11378"/>
                <a:lumOff val="7644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109120"/>
                <a:satOff val="-11378"/>
                <a:lumOff val="7644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,413 proteins</a:t>
          </a:r>
          <a:endParaRPr lang="de-DE" sz="1100" b="1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737885"/>
        <a:ext cx="3181634" cy="605020"/>
      </dsp:txXfrm>
    </dsp:sp>
    <dsp:sp modelId="{F02E4B4A-376F-4589-891C-39658BC12E26}">
      <dsp:nvSpPr>
        <dsp:cNvPr id="0" name=""/>
        <dsp:cNvSpPr/>
      </dsp:nvSpPr>
      <dsp:spPr>
        <a:xfrm>
          <a:off x="2886306" y="1409160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218239"/>
                <a:satOff val="-22757"/>
                <a:lumOff val="1528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218239"/>
                <a:satOff val="-22757"/>
                <a:lumOff val="1528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218239"/>
                <a:satOff val="-22757"/>
                <a:lumOff val="1528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25 </a:t>
          </a: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proteins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 with more than 25% of values below the limit of detection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1441890"/>
        <a:ext cx="3181634" cy="605020"/>
      </dsp:txXfrm>
    </dsp:sp>
    <dsp:sp modelId="{D4ABB1F0-14F4-42E2-B03C-8669D9E40232}">
      <dsp:nvSpPr>
        <dsp:cNvPr id="0" name=""/>
        <dsp:cNvSpPr/>
      </dsp:nvSpPr>
      <dsp:spPr>
        <a:xfrm>
          <a:off x="2886306" y="2113164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327359"/>
                <a:satOff val="-34135"/>
                <a:lumOff val="22933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327359"/>
                <a:satOff val="-34135"/>
                <a:lumOff val="22933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327359"/>
                <a:satOff val="-34135"/>
                <a:lumOff val="22933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10 proteins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more than 20% missing data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2145894"/>
        <a:ext cx="3181634" cy="605020"/>
      </dsp:txXfrm>
    </dsp:sp>
    <dsp:sp modelId="{FA241F88-A4DF-450A-A56D-58C5462F63A2}">
      <dsp:nvSpPr>
        <dsp:cNvPr id="0" name=""/>
        <dsp:cNvSpPr/>
      </dsp:nvSpPr>
      <dsp:spPr>
        <a:xfrm>
          <a:off x="2886306" y="2817168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436479"/>
                <a:satOff val="-45514"/>
                <a:lumOff val="30577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436479"/>
                <a:satOff val="-45514"/>
                <a:lumOff val="30577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436479"/>
                <a:satOff val="-45514"/>
                <a:lumOff val="30577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10 proteins </a:t>
          </a:r>
        </a:p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0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with highly skewed* distribution</a:t>
          </a:r>
          <a:endParaRPr lang="de-DE" sz="1100" b="0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2849898"/>
        <a:ext cx="3181634" cy="605020"/>
      </dsp:txXfrm>
    </dsp:sp>
    <dsp:sp modelId="{41E3352D-5E3F-43FD-B627-E25BACBFD1E3}">
      <dsp:nvSpPr>
        <dsp:cNvPr id="0" name=""/>
        <dsp:cNvSpPr/>
      </dsp:nvSpPr>
      <dsp:spPr>
        <a:xfrm>
          <a:off x="2886306" y="3521173"/>
          <a:ext cx="3247094" cy="670480"/>
        </a:xfrm>
        <a:prstGeom prst="roundRect">
          <a:avLst/>
        </a:prstGeom>
        <a:gradFill rotWithShape="0">
          <a:gsLst>
            <a:gs pos="0">
              <a:schemeClr val="accent1">
                <a:shade val="80000"/>
                <a:hueOff val="545598"/>
                <a:satOff val="-56892"/>
                <a:lumOff val="38221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1">
                <a:shade val="80000"/>
                <a:hueOff val="545598"/>
                <a:satOff val="-56892"/>
                <a:lumOff val="38221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1">
                <a:shade val="80000"/>
                <a:hueOff val="545598"/>
                <a:satOff val="-56892"/>
                <a:lumOff val="38221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1910" tIns="20955" rIns="41910" bIns="20955" numCol="1" spcCol="1270" anchor="t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100" b="1" kern="12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rPr>
            <a:t>5,368 proteins</a:t>
          </a:r>
          <a:endParaRPr lang="de-DE" sz="1100" b="1" kern="1200" dirty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endParaRPr>
        </a:p>
      </dsp:txBody>
      <dsp:txXfrm>
        <a:off x="2919036" y="3553903"/>
        <a:ext cx="3181634" cy="60502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5">
  <dgm:title val=""/>
  <dgm:desc val=""/>
  <dgm:catLst>
    <dgm:cat type="list" pri="15000"/>
    <dgm:cat type="convert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5"/>
      <dgm:constr type="primFontSz" for="des" forName="parentText" op="equ" val="65"/>
      <dgm:constr type="secFontSz" for="des" forName="descendantText" op="equ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36"/>
          <dgm:constr type="w" for="ch" forName="descendantText" refType="w" fact="0.64"/>
          <dgm:constr type="h" for="ch" forName="parentText" refType="h"/>
          <dgm:constr type="h" for="ch" forName="descendantText" refType="h" refFor="ch" refForName="parentText" fact="0.8"/>
        </dgm:constrLst>
        <dgm:ruleLst/>
        <dgm:layoutNode name="parentText">
          <dgm:varLst>
            <dgm:chMax val="1"/>
            <dgm:bulletEnabled val="1"/>
          </dgm:varLst>
          <dgm:alg type="tx"/>
          <dgm:shape xmlns:r="http://schemas.openxmlformats.org/officeDocument/2006/relationships" type="roundRect" r:blip="" zOrderOff="3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choose name="Name8">
          <dgm:if name="Name9" axis="ch" ptType="node" func="cnt" op="gte" val="1">
            <dgm:layoutNode name="descendantText" styleLbl="alignAccFollow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choose name="Name10">
                <dgm:if name="Name11" func="var" arg="dir" op="equ" val="norm">
                  <dgm:shape xmlns:r="http://schemas.openxmlformats.org/officeDocument/2006/relationships" rot="90" type="round2SameRect" r:blip="">
                    <dgm:adjLst/>
                  </dgm:shape>
                </dgm:if>
                <dgm:else name="Name12">
                  <dgm:shape xmlns:r="http://schemas.openxmlformats.org/officeDocument/2006/relationships" rot="-90" type="round2SameRect" r:blip="">
                    <dgm:adjLst/>
                  </dgm:shape>
                </dgm:else>
              </dgm:choose>
              <dgm:presOf axis="des" ptType="node"/>
              <dgm:constrLst>
                <dgm:constr type="secFontSz" val="65"/>
                <dgm:constr type="primFontSz" refType="secFontSz"/>
                <dgm:constr type="lMarg" refType="secFontSz" fact="0.3"/>
                <dgm:constr type="rMarg" refType="secFontSz" fact="0.3"/>
                <dgm:constr type="tMarg" refType="secFontSz" fact="0.15"/>
                <dgm:constr type="bMarg" refType="secFontSz" fact="0.15"/>
              </dgm:constrLst>
              <dgm:ruleLst>
                <dgm:rule type="sec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List5">
  <dgm:title val=""/>
  <dgm:desc val=""/>
  <dgm:catLst>
    <dgm:cat type="list" pri="15000"/>
    <dgm:cat type="convert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5"/>
      <dgm:constr type="primFontSz" for="des" forName="parentText" op="equ" val="65"/>
      <dgm:constr type="secFontSz" for="des" forName="descendantText" op="equ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36"/>
          <dgm:constr type="w" for="ch" forName="descendantText" refType="w" fact="0.64"/>
          <dgm:constr type="h" for="ch" forName="parentText" refType="h"/>
          <dgm:constr type="h" for="ch" forName="descendantText" refType="h" refFor="ch" refForName="parentText" fact="0.8"/>
        </dgm:constrLst>
        <dgm:ruleLst/>
        <dgm:layoutNode name="parentText">
          <dgm:varLst>
            <dgm:chMax val="1"/>
            <dgm:bulletEnabled val="1"/>
          </dgm:varLst>
          <dgm:alg type="tx"/>
          <dgm:shape xmlns:r="http://schemas.openxmlformats.org/officeDocument/2006/relationships" type="roundRect" r:blip="" zOrderOff="3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choose name="Name8">
          <dgm:if name="Name9" axis="ch" ptType="node" func="cnt" op="gte" val="1">
            <dgm:layoutNode name="descendantText" styleLbl="alignAccFollow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choose name="Name10">
                <dgm:if name="Name11" func="var" arg="dir" op="equ" val="norm">
                  <dgm:shape xmlns:r="http://schemas.openxmlformats.org/officeDocument/2006/relationships" rot="90" type="round2SameRect" r:blip="">
                    <dgm:adjLst/>
                  </dgm:shape>
                </dgm:if>
                <dgm:else name="Name12">
                  <dgm:shape xmlns:r="http://schemas.openxmlformats.org/officeDocument/2006/relationships" rot="-90" type="round2SameRect" r:blip="">
                    <dgm:adjLst/>
                  </dgm:shape>
                </dgm:else>
              </dgm:choose>
              <dgm:presOf axis="des" ptType="node"/>
              <dgm:constrLst>
                <dgm:constr type="secFontSz" val="65"/>
                <dgm:constr type="primFontSz" refType="secFontSz"/>
                <dgm:constr type="lMarg" refType="secFontSz" fact="0.3"/>
                <dgm:constr type="rMarg" refType="secFontSz" fact="0.3"/>
                <dgm:constr type="tMarg" refType="secFontSz" fact="0.15"/>
                <dgm:constr type="bMarg" refType="secFontSz" fact="0.15"/>
              </dgm:constrLst>
              <dgm:ruleLst>
                <dgm:rule type="sec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B3B93D-065E-4363-97D0-6C034133265E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3ED16-6A78-4B85-8972-50EF00B0951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0862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29516-A70B-BCAA-7D2D-790C987894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F6CE83-CA22-F37F-C81F-2AC42F6220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F179A0-4A4A-1649-7AD5-DDF680D43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7FCF1F-CEC6-54D2-E965-0D88C796F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789FE-2D77-DBC6-F628-86D8CA3F1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866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616D3-719F-99A8-2BE1-110F59CD9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BDABC2-7EAE-1B6B-6002-6DF6919536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C94BC-0A33-D2F1-D810-054572DD2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56417-57F6-877E-8B12-66292FCC5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39A66-38EE-0682-3A77-8E4D56042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6500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CC2C7E-8233-F0C2-F350-099950AD43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A84930-59BB-6AD5-1847-0875CDC9AA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B2B68D-C605-692E-32FF-08931A3C5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AE8769-8024-57D6-7E84-1BE3461C5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0D5575-80B3-6447-6423-F5061AEA7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7543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394B3-C95A-97BD-97E8-5515409BA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8726B0-AC6F-FB6A-9596-0DD5A6CAB9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E9C0E5-B75A-E0FD-79BC-0F2698010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224994-A41B-10FD-E4A2-78AC9F091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480018-495E-76A7-A8E2-619024E38B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257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6A407-2D4C-F439-69AE-081BFF373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A02C5C-84AD-514D-C87B-65E2D46464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7B7CC9-3E57-2ED5-1644-AA50654D2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F412E0-E69F-FD4E-67F1-18EE9A860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BF3FB4-0EAD-5D35-2975-8E7228CB7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61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0CFD64-B522-E429-246C-9197D718B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E89942-748B-57A4-1CB9-D8957E65CA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9E305D-58FF-30AF-1409-D865BD4936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937226-D16F-4E09-2C36-516CEFF70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655CDE-6E55-6D9E-F01B-2E96CCB32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12AC68-3AF5-769D-771B-380E3D6A9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2060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3C34C-B6D6-6793-D934-CD7F33DE0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DC9F62-0B43-9B98-63ED-CD7B89B63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80634D-D3A0-0410-9F4A-AB00C17736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7C593F-2890-2CA2-BD8B-B712F28A3B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307962-AB65-0F1B-5276-AAA896B127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0187BA-4256-EE10-9E19-BD786A3A8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FDA32C-43A7-F8B4-BDFE-393169CF8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C6B203-429C-760D-A6B7-26AF44C08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5188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D5121F-590D-49DE-2DD0-12FE7D79C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BD10F-EAA5-7366-9E53-8DC36B75F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AA40E9-8D37-CFB9-5634-3B6571EA3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B335CF-87F7-A80E-2BEB-DB3247CC8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3565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FC37F3-76A4-6444-506E-84050AEF8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55AEF8-1838-D416-DED7-DD38F5311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B6EFF3-4C60-3496-6FA7-BB0A884CB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156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37148-0177-5847-07D0-8FFDE6B8F3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AD600C-B48E-C7B9-40BE-303638F102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B7A2DF-86A4-731F-35DF-3DF2F074F4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33D230-93E2-658B-0A40-A7A7B1CE4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F2572F-02CE-C944-E855-A825627B9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5738A6-F139-5102-2C4B-397BBCA21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8439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7268A-81A4-C3B8-F5B4-51A833BDF2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AE280C-41F5-E512-BD82-25A9BD9097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892D0B-3350-031B-9C20-C4EE17BB62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1B4926-B4FC-57D1-C5B4-036E66AB5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39468D-B564-76A0-7666-77D290EBC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FD2E2B-B3D3-4A0A-F6EF-541AB22FD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9617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3EF1BB-223A-7A7B-9A49-0AA65CDF6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279E0E-7109-6503-4453-A5CD14308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D933FD-8698-0E3A-A469-8AFAD56890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F7A027-851B-4230-A3BC-78624802B3B0}" type="datetimeFigureOut">
              <a:rPr lang="de-DE" smtClean="0"/>
              <a:t>01.11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602BC-29C8-F50F-EE37-BA90940DB0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87CC3-DEEF-5B3D-9215-2CB5C31BF2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696FA6-8B3D-4EEF-A65F-E6219CB36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856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D58AA95B-6E88-8FFC-4CD7-7F76A2A1594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097A8890-196D-91E6-27DF-3CDA50BC70B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8809368"/>
              </p:ext>
            </p:extLst>
          </p:nvPr>
        </p:nvGraphicFramePr>
        <p:xfrm>
          <a:off x="-661671" y="678415"/>
          <a:ext cx="9019708" cy="419280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E0A8292B-4E01-37CF-1A98-6F1E5DEBB1A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35790629"/>
              </p:ext>
            </p:extLst>
          </p:nvPr>
        </p:nvGraphicFramePr>
        <p:xfrm>
          <a:off x="2666622" y="678415"/>
          <a:ext cx="9019708" cy="419280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5" name="Arrow: Down 4">
            <a:extLst>
              <a:ext uri="{FF2B5EF4-FFF2-40B4-BE49-F238E27FC236}">
                <a16:creationId xmlns:a16="http://schemas.microsoft.com/office/drawing/2014/main" id="{E1176FBF-DA66-4D6F-B574-9776C4C762D0}"/>
              </a:ext>
            </a:extLst>
          </p:cNvPr>
          <p:cNvSpPr/>
          <p:nvPr/>
        </p:nvSpPr>
        <p:spPr>
          <a:xfrm flipH="1">
            <a:off x="3708926" y="2668259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31E5647F-BB71-42A0-8B95-BEC3918C78E3}"/>
              </a:ext>
            </a:extLst>
          </p:cNvPr>
          <p:cNvSpPr/>
          <p:nvPr/>
        </p:nvSpPr>
        <p:spPr>
          <a:xfrm flipH="1">
            <a:off x="3708926" y="1251645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2C8F120E-071C-4243-97FE-A69D1C2A3267}"/>
              </a:ext>
            </a:extLst>
          </p:cNvPr>
          <p:cNvSpPr/>
          <p:nvPr/>
        </p:nvSpPr>
        <p:spPr>
          <a:xfrm flipH="1">
            <a:off x="3706780" y="1959952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F2A826A9-BD44-4C79-B1EB-D082D7D5AC78}"/>
              </a:ext>
            </a:extLst>
          </p:cNvPr>
          <p:cNvSpPr/>
          <p:nvPr/>
        </p:nvSpPr>
        <p:spPr>
          <a:xfrm flipH="1">
            <a:off x="3706780" y="3368451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Arrow: Down 21">
            <a:extLst>
              <a:ext uri="{FF2B5EF4-FFF2-40B4-BE49-F238E27FC236}">
                <a16:creationId xmlns:a16="http://schemas.microsoft.com/office/drawing/2014/main" id="{754FC186-4A48-4F63-98F2-4DD177C86831}"/>
              </a:ext>
            </a:extLst>
          </p:cNvPr>
          <p:cNvSpPr/>
          <p:nvPr/>
        </p:nvSpPr>
        <p:spPr>
          <a:xfrm flipH="1">
            <a:off x="7032926" y="1251646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C4CBFC42-A9DD-4497-8755-1F88FF7729D5}"/>
              </a:ext>
            </a:extLst>
          </p:cNvPr>
          <p:cNvSpPr/>
          <p:nvPr/>
        </p:nvSpPr>
        <p:spPr>
          <a:xfrm flipH="1">
            <a:off x="7032926" y="1959953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A89CE0DF-80F9-40CE-BE09-0B19CC1A9C79}"/>
              </a:ext>
            </a:extLst>
          </p:cNvPr>
          <p:cNvSpPr/>
          <p:nvPr/>
        </p:nvSpPr>
        <p:spPr>
          <a:xfrm flipH="1">
            <a:off x="7032925" y="2684817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FAFF9551-62BD-42BA-A450-1BABDD024DC7}"/>
              </a:ext>
            </a:extLst>
          </p:cNvPr>
          <p:cNvSpPr/>
          <p:nvPr/>
        </p:nvSpPr>
        <p:spPr>
          <a:xfrm flipH="1">
            <a:off x="7032925" y="3371683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Arrow: Down 26">
            <a:extLst>
              <a:ext uri="{FF2B5EF4-FFF2-40B4-BE49-F238E27FC236}">
                <a16:creationId xmlns:a16="http://schemas.microsoft.com/office/drawing/2014/main" id="{A83C8633-DCA6-4F66-AB98-6A324EF3D83D}"/>
              </a:ext>
            </a:extLst>
          </p:cNvPr>
          <p:cNvSpPr/>
          <p:nvPr/>
        </p:nvSpPr>
        <p:spPr>
          <a:xfrm flipH="1">
            <a:off x="7032924" y="4062513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F724FD95-94C8-4895-A984-2FB2B3EDDF31}"/>
              </a:ext>
            </a:extLst>
          </p:cNvPr>
          <p:cNvSpPr/>
          <p:nvPr/>
        </p:nvSpPr>
        <p:spPr>
          <a:xfrm flipH="1">
            <a:off x="3706779" y="4048689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D5466022-7E1D-4C67-8560-1A1DC5303622}"/>
              </a:ext>
            </a:extLst>
          </p:cNvPr>
          <p:cNvSpPr/>
          <p:nvPr/>
        </p:nvSpPr>
        <p:spPr>
          <a:xfrm>
            <a:off x="3044036" y="4902480"/>
            <a:ext cx="4834255" cy="659765"/>
          </a:xfrm>
          <a:prstGeom prst="round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kern="100" dirty="0">
                <a:effectLst/>
                <a:latin typeface="Calibri" panose="020F0502020204030204" pitchFamily="34" charset="0"/>
                <a:ea typeface="Aptos"/>
                <a:cs typeface="Times New Roman" panose="02020603050405020304" pitchFamily="18" charset="0"/>
              </a:rPr>
              <a:t>2,025 proteins overlapping in both the datasets</a:t>
            </a:r>
            <a:endParaRPr lang="de-DE" sz="1100" b="1" kern="100" dirty="0">
              <a:effectLst/>
              <a:ea typeface="Aptos"/>
              <a:cs typeface="Times New Roman" panose="02020603050405020304" pitchFamily="18" charset="0"/>
            </a:endParaRPr>
          </a:p>
        </p:txBody>
      </p:sp>
      <p:sp>
        <p:nvSpPr>
          <p:cNvPr id="21" name="Arrow: Down 20">
            <a:extLst>
              <a:ext uri="{FF2B5EF4-FFF2-40B4-BE49-F238E27FC236}">
                <a16:creationId xmlns:a16="http://schemas.microsoft.com/office/drawing/2014/main" id="{B7D8ECD8-492A-43D4-8E33-384B5DF434E2}"/>
              </a:ext>
            </a:extLst>
          </p:cNvPr>
          <p:cNvSpPr/>
          <p:nvPr/>
        </p:nvSpPr>
        <p:spPr>
          <a:xfrm flipH="1">
            <a:off x="3706779" y="4774175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Arrow: Down 27">
            <a:extLst>
              <a:ext uri="{FF2B5EF4-FFF2-40B4-BE49-F238E27FC236}">
                <a16:creationId xmlns:a16="http://schemas.microsoft.com/office/drawing/2014/main" id="{7A00845B-2844-4A14-BC84-C115D9DBCCC5}"/>
              </a:ext>
            </a:extLst>
          </p:cNvPr>
          <p:cNvSpPr/>
          <p:nvPr/>
        </p:nvSpPr>
        <p:spPr>
          <a:xfrm flipH="1">
            <a:off x="7032926" y="4774176"/>
            <a:ext cx="141403" cy="180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A36BAF6-8F1C-453A-A975-22409DE12C52}"/>
              </a:ext>
            </a:extLst>
          </p:cNvPr>
          <p:cNvSpPr/>
          <p:nvPr/>
        </p:nvSpPr>
        <p:spPr>
          <a:xfrm>
            <a:off x="2085975" y="5726666"/>
            <a:ext cx="1040129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processing of the protein biomarker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 UK Biobank and ESTHER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</a:p>
          <a:p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e skewness values beyond -3 and +3 were considered highly skewed.</a:t>
            </a:r>
          </a:p>
        </p:txBody>
      </p:sp>
    </p:spTree>
    <p:extLst>
      <p:ext uri="{BB962C8B-B14F-4D97-AF65-F5344CB8AC3E}">
        <p14:creationId xmlns:p14="http://schemas.microsoft.com/office/powerpoint/2010/main" val="1630310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tinkumar Sharma</dc:creator>
  <cp:lastModifiedBy>Nitinkumar Sharma</cp:lastModifiedBy>
  <cp:revision>14</cp:revision>
  <dcterms:created xsi:type="dcterms:W3CDTF">2024-10-17T10:39:21Z</dcterms:created>
  <dcterms:modified xsi:type="dcterms:W3CDTF">2025-11-01T16:59:15Z</dcterms:modified>
</cp:coreProperties>
</file>